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6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76" d="100"/>
          <a:sy n="176" d="100"/>
        </p:scale>
        <p:origin x="-208" y="-29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4318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50959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0379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3426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9940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4480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9679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06087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6275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4247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4463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1F777D-AE26-405F-9761-EB667DFE731C}" type="datetimeFigureOut">
              <a:rPr lang="it-IT" smtClean="0"/>
              <a:t>21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9584D5-87CC-49A5-9B1D-09270F92141E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2872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D5D121BA-15E6-4A42-ACAE-D0CA4FC9F55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124" b="39564"/>
          <a:stretch/>
        </p:blipFill>
        <p:spPr>
          <a:xfrm>
            <a:off x="369000" y="2034283"/>
            <a:ext cx="6120000" cy="353431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8A4A2BC7-8BFA-4356-B607-453762795849}"/>
              </a:ext>
            </a:extLst>
          </p:cNvPr>
          <p:cNvSpPr txBox="1"/>
          <p:nvPr/>
        </p:nvSpPr>
        <p:spPr>
          <a:xfrm>
            <a:off x="1629000" y="6239192"/>
            <a:ext cx="412738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 dependence of the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opoleti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SCT) absorption spectra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it-IT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06806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54653E11-990C-4BE2-8E77-CA4497E38FC4}"/>
              </a:ext>
            </a:extLst>
          </p:cNvPr>
          <p:cNvSpPr txBox="1"/>
          <p:nvPr/>
        </p:nvSpPr>
        <p:spPr>
          <a:xfrm>
            <a:off x="1629000" y="6239192"/>
            <a:ext cx="412738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between the 360 nm and 385 nm fluorescence excitation bands (F</a:t>
            </a:r>
            <a:r>
              <a:rPr lang="en-GB" sz="12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60_460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F</a:t>
            </a:r>
            <a:r>
              <a:rPr lang="en-GB" sz="12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85_460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GB" sz="1200" u="sng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polin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) or CGA (B) concentrations.</a:t>
            </a:r>
            <a:endParaRPr lang="it-IT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id="{38ADAAAD-B3D2-48AC-A5C2-ED35260120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9000" y="929894"/>
            <a:ext cx="3600000" cy="50923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15490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5</Words>
  <Application>Microsoft Office PowerPoint</Application>
  <PresentationFormat>Presentazione su schermo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ovanni Agati</dc:creator>
  <cp:lastModifiedBy>Giovanni Agati</cp:lastModifiedBy>
  <cp:revision>3</cp:revision>
  <dcterms:created xsi:type="dcterms:W3CDTF">2022-02-26T15:16:16Z</dcterms:created>
  <dcterms:modified xsi:type="dcterms:W3CDTF">2022-03-21T10:30:59Z</dcterms:modified>
</cp:coreProperties>
</file>